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02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090826D-C048-3C47-AD86-D230EB802429}" v="7" dt="2024-08-16T20:38:38.5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9"/>
    <p:restoredTop sz="95728"/>
  </p:normalViewPr>
  <p:slideViewPr>
    <p:cSldViewPr snapToGrid="0">
      <p:cViewPr varScale="1">
        <p:scale>
          <a:sx n="64" d="100"/>
          <a:sy n="64" d="100"/>
        </p:scale>
        <p:origin x="192" y="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63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515100" y="13243265"/>
            <a:ext cx="1397725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Mouse Immune Panel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otein expression of LEGENDplex Mouse Immune Response panel of tumors from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of TAM inhibition using BLZ945, CSF-R1 inhibitor, and/or carboplatin for pre- and relapse, total concentrations (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. Two-way ANOVA, Tukey post-hoc test. Mean and SEM. *p&lt;0.05, no stars indicate n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30618E7-DC9D-95C9-CF95-CB866D0E1E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514529"/>
            <a:ext cx="15562264" cy="12728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719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84</TotalTime>
  <Words>70</Words>
  <Application>Microsoft Macintosh PowerPoint</Application>
  <PresentationFormat>Custom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79</cp:revision>
  <dcterms:created xsi:type="dcterms:W3CDTF">2022-01-18T04:14:07Z</dcterms:created>
  <dcterms:modified xsi:type="dcterms:W3CDTF">2024-08-20T23:34:58Z</dcterms:modified>
</cp:coreProperties>
</file>